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5" r:id="rId2"/>
    <p:sldId id="277" r:id="rId3"/>
    <p:sldId id="284" r:id="rId4"/>
    <p:sldId id="287" r:id="rId5"/>
    <p:sldId id="288" r:id="rId6"/>
    <p:sldId id="290" r:id="rId7"/>
    <p:sldId id="292" r:id="rId8"/>
    <p:sldId id="293" r:id="rId9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89" autoAdjust="0"/>
    <p:restoredTop sz="94677"/>
  </p:normalViewPr>
  <p:slideViewPr>
    <p:cSldViewPr snapToGrid="0" snapToObjects="1">
      <p:cViewPr varScale="1">
        <p:scale>
          <a:sx n="57" d="100"/>
          <a:sy n="57" d="100"/>
        </p:scale>
        <p:origin x="31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557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9751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894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1111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799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17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331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77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410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033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8458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CB5DD-F3FB-DB40-940E-C7EA36D39137}" type="datetimeFigureOut">
              <a:t>2018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1FFE9-6B3E-024B-8A19-6DA83D96D2B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177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701037B-8CC7-8144-80B9-D06C5B6EF2DB}"/>
              </a:ext>
            </a:extLst>
          </p:cNvPr>
          <p:cNvGrpSpPr/>
          <p:nvPr/>
        </p:nvGrpSpPr>
        <p:grpSpPr>
          <a:xfrm>
            <a:off x="201706" y="1325458"/>
            <a:ext cx="6454588" cy="2612364"/>
            <a:chOff x="0" y="4764526"/>
            <a:chExt cx="6858000" cy="2775637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B359BB0C-2D87-E04E-BDED-3EA3D72E15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764526"/>
              <a:ext cx="6858000" cy="376947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B4825280-1365-1645-B153-04CB253970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141473"/>
              <a:ext cx="6858000" cy="2398690"/>
            </a:xfrm>
            <a:prstGeom prst="rect">
              <a:avLst/>
            </a:prstGeom>
          </p:spPr>
        </p:pic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B861ECDF-CBE1-3C48-9EAC-F927EDEE9AF6}"/>
              </a:ext>
            </a:extLst>
          </p:cNvPr>
          <p:cNvGrpSpPr/>
          <p:nvPr/>
        </p:nvGrpSpPr>
        <p:grpSpPr>
          <a:xfrm>
            <a:off x="201706" y="4152063"/>
            <a:ext cx="6454588" cy="2601354"/>
            <a:chOff x="0" y="4766443"/>
            <a:chExt cx="6858000" cy="2763939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3BB67E22-F6F8-6F47-AD7E-534E09386E2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766443"/>
              <a:ext cx="6858000" cy="373114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1562EF23-88C1-0242-BAD0-F02510DF0CE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139557"/>
              <a:ext cx="6858000" cy="2390825"/>
            </a:xfrm>
            <a:prstGeom prst="rect">
              <a:avLst/>
            </a:prstGeom>
          </p:spPr>
        </p:pic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4A3BE483-4A8B-4C48-8938-AC7A6BBA191D}"/>
              </a:ext>
            </a:extLst>
          </p:cNvPr>
          <p:cNvGrpSpPr/>
          <p:nvPr/>
        </p:nvGrpSpPr>
        <p:grpSpPr>
          <a:xfrm>
            <a:off x="201706" y="6967658"/>
            <a:ext cx="6454588" cy="2510394"/>
            <a:chOff x="0" y="4819402"/>
            <a:chExt cx="6858000" cy="2667294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7D55A40C-AA5B-DC44-AED7-3BE05A435F7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819402"/>
              <a:ext cx="6858000" cy="267195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051B7E5B-E8F1-B142-AE71-2FC89755180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086597"/>
              <a:ext cx="6858000" cy="2400099"/>
            </a:xfrm>
            <a:prstGeom prst="rect">
              <a:avLst/>
            </a:prstGeom>
          </p:spPr>
        </p:pic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DDD6FF-6A92-4A31-A5FA-1D2CF62AA4EE}"/>
              </a:ext>
            </a:extLst>
          </p:cNvPr>
          <p:cNvSpPr txBox="1"/>
          <p:nvPr/>
        </p:nvSpPr>
        <p:spPr>
          <a:xfrm>
            <a:off x="416859" y="594073"/>
            <a:ext cx="6156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complete deletion of 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pnc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584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77BC40F1-090D-FA41-AFE9-466C9B9E0F52}"/>
              </a:ext>
            </a:extLst>
          </p:cNvPr>
          <p:cNvGrpSpPr/>
          <p:nvPr/>
        </p:nvGrpSpPr>
        <p:grpSpPr>
          <a:xfrm>
            <a:off x="299790" y="1969619"/>
            <a:ext cx="6258420" cy="2517996"/>
            <a:chOff x="0" y="4768797"/>
            <a:chExt cx="6858000" cy="2759230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F288B405-07E9-0849-A57F-7963066C44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768797"/>
              <a:ext cx="6858000" cy="368405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BC3878CA-6D79-4746-AD2F-EF362A53AD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137202"/>
              <a:ext cx="6858000" cy="2390825"/>
            </a:xfrm>
            <a:prstGeom prst="rect">
              <a:avLst/>
            </a:prstGeom>
          </p:spPr>
        </p:pic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9A785B96-F4CC-4E1D-8420-DF1B2DE249E6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9791" y="5418385"/>
            <a:ext cx="6258419" cy="219265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DD2F2E9-A916-4A85-8110-AE52A9002306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9784" y="5022547"/>
            <a:ext cx="6258426" cy="34009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E67D661-DCD1-4F91-B5D9-1FE92BE1C382}"/>
              </a:ext>
            </a:extLst>
          </p:cNvPr>
          <p:cNvSpPr txBox="1"/>
          <p:nvPr/>
        </p:nvSpPr>
        <p:spPr>
          <a:xfrm>
            <a:off x="156277" y="609922"/>
            <a:ext cx="6545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deletion of 3’ end of 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pnc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4545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D764F95-B8A2-4542-A4F9-33D373F9C097}"/>
              </a:ext>
            </a:extLst>
          </p:cNvPr>
          <p:cNvGrpSpPr/>
          <p:nvPr/>
        </p:nvGrpSpPr>
        <p:grpSpPr>
          <a:xfrm>
            <a:off x="493134" y="1347162"/>
            <a:ext cx="5983941" cy="3605838"/>
            <a:chOff x="0" y="2021120"/>
            <a:chExt cx="6858000" cy="4132533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048E83C-8348-2240-9430-2DC9367C6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3752347"/>
              <a:ext cx="6858000" cy="240130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90A0BEE3-EDFC-E245-85FD-C510269514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2021120"/>
              <a:ext cx="6858000" cy="1731227"/>
            </a:xfrm>
            <a:prstGeom prst="rect">
              <a:avLst/>
            </a:prstGeom>
          </p:spPr>
        </p:pic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0F66EC8-D29D-964F-877B-9F1723CAB27C}"/>
              </a:ext>
            </a:extLst>
          </p:cNvPr>
          <p:cNvGrpSpPr/>
          <p:nvPr/>
        </p:nvGrpSpPr>
        <p:grpSpPr>
          <a:xfrm>
            <a:off x="493134" y="6053256"/>
            <a:ext cx="5983941" cy="2346232"/>
            <a:chOff x="0" y="4807171"/>
            <a:chExt cx="6858000" cy="2688940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316AF35D-51B9-144A-9D05-700BAAD348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807171"/>
              <a:ext cx="6858000" cy="291657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00770A08-72FE-914C-975E-D7CE2E2FD34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098828"/>
              <a:ext cx="6858000" cy="2397283"/>
            </a:xfrm>
            <a:prstGeom prst="rect">
              <a:avLst/>
            </a:prstGeom>
          </p:spPr>
        </p:pic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E9E698F-7D2A-4967-BEB7-29213B0BF923}"/>
              </a:ext>
            </a:extLst>
          </p:cNvPr>
          <p:cNvSpPr/>
          <p:nvPr/>
        </p:nvSpPr>
        <p:spPr>
          <a:xfrm>
            <a:off x="3827854" y="5125961"/>
            <a:ext cx="25577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1834845: TCGCCGCCG</a:t>
            </a:r>
            <a:r>
              <a:rPr lang="ja-JP" alt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G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/TCGCCGCCG)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B24DDB65-6415-4938-B081-CFFA74007B0D}"/>
              </a:ext>
            </a:extLst>
          </p:cNvPr>
          <p:cNvSpPr/>
          <p:nvPr/>
        </p:nvSpPr>
        <p:spPr>
          <a:xfrm>
            <a:off x="2414344" y="5125961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D23C3A4-C0B3-47BD-9E67-6DCE06A9E50F}"/>
              </a:ext>
            </a:extLst>
          </p:cNvPr>
          <p:cNvSpPr/>
          <p:nvPr/>
        </p:nvSpPr>
        <p:spPr>
          <a:xfrm>
            <a:off x="4174564" y="8683684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1D5D5192-7E40-4E4B-B50F-A364613BCA32}"/>
              </a:ext>
            </a:extLst>
          </p:cNvPr>
          <p:cNvSpPr/>
          <p:nvPr/>
        </p:nvSpPr>
        <p:spPr>
          <a:xfrm>
            <a:off x="2656914" y="8683684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123Ala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4B0F552-A6C6-4B08-8413-40D2ADFA1424}"/>
              </a:ext>
            </a:extLst>
          </p:cNvPr>
          <p:cNvSpPr txBox="1"/>
          <p:nvPr/>
        </p:nvSpPr>
        <p:spPr>
          <a:xfrm>
            <a:off x="567391" y="621905"/>
            <a:ext cx="561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s in </a:t>
            </a:r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BF424155-6D49-4A2C-9ECA-F2F0E714BCAA}"/>
              </a:ext>
            </a:extLst>
          </p:cNvPr>
          <p:cNvCxnSpPr/>
          <p:nvPr/>
        </p:nvCxnSpPr>
        <p:spPr>
          <a:xfrm flipV="1">
            <a:off x="3352800" y="4718451"/>
            <a:ext cx="527124" cy="4058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8825A5ED-CC2A-414A-AA01-D91B9C388B08}"/>
              </a:ext>
            </a:extLst>
          </p:cNvPr>
          <p:cNvCxnSpPr/>
          <p:nvPr/>
        </p:nvCxnSpPr>
        <p:spPr>
          <a:xfrm flipV="1">
            <a:off x="5222240" y="4716074"/>
            <a:ext cx="527124" cy="4058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1BF1AC85-F65C-43D8-A0CA-94A8ACBD23C5}"/>
              </a:ext>
            </a:extLst>
          </p:cNvPr>
          <p:cNvCxnSpPr>
            <a:cxnSpLocks/>
          </p:cNvCxnSpPr>
          <p:nvPr/>
        </p:nvCxnSpPr>
        <p:spPr>
          <a:xfrm flipV="1">
            <a:off x="2978076" y="8087360"/>
            <a:ext cx="303604" cy="49103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B8BF9530-72D5-4B74-B421-5AE508D92EE9}"/>
              </a:ext>
            </a:extLst>
          </p:cNvPr>
          <p:cNvCxnSpPr>
            <a:cxnSpLocks/>
          </p:cNvCxnSpPr>
          <p:nvPr/>
        </p:nvCxnSpPr>
        <p:spPr>
          <a:xfrm flipH="1" flipV="1">
            <a:off x="4299903" y="8092466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00866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13779A2-FAE5-1E49-AB47-57BEC7B3B271}"/>
              </a:ext>
            </a:extLst>
          </p:cNvPr>
          <p:cNvGrpSpPr/>
          <p:nvPr/>
        </p:nvGrpSpPr>
        <p:grpSpPr>
          <a:xfrm>
            <a:off x="474150" y="939107"/>
            <a:ext cx="5621850" cy="4213727"/>
            <a:chOff x="1" y="3277627"/>
            <a:chExt cx="6858000" cy="5140255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B2DFF669-E335-894D-ACB9-3343DA0BF9F4}"/>
                </a:ext>
              </a:extLst>
            </p:cNvPr>
            <p:cNvGrpSpPr/>
            <p:nvPr/>
          </p:nvGrpSpPr>
          <p:grpSpPr>
            <a:xfrm>
              <a:off x="1" y="3277627"/>
              <a:ext cx="6850820" cy="2752237"/>
              <a:chOff x="-1138687" y="3156857"/>
              <a:chExt cx="8951789" cy="3596277"/>
            </a:xfrm>
          </p:grpSpPr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56963CD3-38EA-EA49-AE23-0900767A6E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-1138687" y="3160848"/>
                <a:ext cx="6858000" cy="3592286"/>
              </a:xfrm>
              <a:prstGeom prst="rect">
                <a:avLst/>
              </a:prstGeom>
            </p:spPr>
          </p:pic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0A2F7A2E-62D4-7944-A74F-BE89C6B254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719313" y="3156857"/>
                <a:ext cx="2093789" cy="3596277"/>
              </a:xfrm>
              <a:prstGeom prst="rect">
                <a:avLst/>
              </a:prstGeom>
            </p:spPr>
          </p:pic>
        </p:grp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0537C168-429F-1F46-B1E7-F72F7A5AF6F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" y="6029864"/>
              <a:ext cx="6858000" cy="2388018"/>
            </a:xfrm>
            <a:prstGeom prst="rect">
              <a:avLst/>
            </a:prstGeom>
          </p:spPr>
        </p:pic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95D39AF0-C7D7-6F4D-B5CA-86281A5BE3E2}"/>
              </a:ext>
            </a:extLst>
          </p:cNvPr>
          <p:cNvGrpSpPr/>
          <p:nvPr/>
        </p:nvGrpSpPr>
        <p:grpSpPr>
          <a:xfrm>
            <a:off x="484012" y="5789808"/>
            <a:ext cx="5621850" cy="3240782"/>
            <a:chOff x="0" y="4172943"/>
            <a:chExt cx="6858000" cy="3953375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C7BC4938-CB39-3D4F-982C-D2D57B6F2E9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172943"/>
              <a:ext cx="6858000" cy="1560114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2594F1FB-6667-4842-ABC9-5357E3629AD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733057"/>
              <a:ext cx="6858000" cy="2393261"/>
            </a:xfrm>
            <a:prstGeom prst="rect">
              <a:avLst/>
            </a:prstGeom>
          </p:spPr>
        </p:pic>
      </p:grp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6F55F16-C397-4683-895F-3C2BDA9E3E17}"/>
              </a:ext>
            </a:extLst>
          </p:cNvPr>
          <p:cNvSpPr/>
          <p:nvPr/>
        </p:nvSpPr>
        <p:spPr>
          <a:xfrm>
            <a:off x="2290367" y="5299916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sp27Asn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165E301-7F60-4965-A7F7-32D6619A3CF5}"/>
              </a:ext>
            </a:extLst>
          </p:cNvPr>
          <p:cNvSpPr/>
          <p:nvPr/>
        </p:nvSpPr>
        <p:spPr>
          <a:xfrm>
            <a:off x="3435442" y="9272393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67B6B23C-2826-4641-BE16-C2E81B593371}"/>
              </a:ext>
            </a:extLst>
          </p:cNvPr>
          <p:cNvSpPr/>
          <p:nvPr/>
        </p:nvSpPr>
        <p:spPr>
          <a:xfrm>
            <a:off x="1819495" y="9378397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123Ala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6F91178-18E5-464A-AF4A-623EB1A8AC1E}"/>
              </a:ext>
            </a:extLst>
          </p:cNvPr>
          <p:cNvSpPr txBox="1"/>
          <p:nvPr/>
        </p:nvSpPr>
        <p:spPr>
          <a:xfrm>
            <a:off x="487977" y="343745"/>
            <a:ext cx="561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s in </a:t>
            </a:r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A11A7F81-9B2B-44A3-A26E-904587590C19}"/>
              </a:ext>
            </a:extLst>
          </p:cNvPr>
          <p:cNvCxnSpPr>
            <a:cxnSpLocks/>
          </p:cNvCxnSpPr>
          <p:nvPr/>
        </p:nvCxnSpPr>
        <p:spPr>
          <a:xfrm flipH="1" flipV="1">
            <a:off x="3917556" y="8786465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2E25FA5-7B95-4855-ADD7-5A3434862438}"/>
              </a:ext>
            </a:extLst>
          </p:cNvPr>
          <p:cNvCxnSpPr>
            <a:cxnSpLocks/>
          </p:cNvCxnSpPr>
          <p:nvPr/>
        </p:nvCxnSpPr>
        <p:spPr>
          <a:xfrm flipV="1">
            <a:off x="2165029" y="8787626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BDEF42DA-8AF7-45D9-82E0-687FEB7CD32A}"/>
              </a:ext>
            </a:extLst>
          </p:cNvPr>
          <p:cNvCxnSpPr>
            <a:cxnSpLocks/>
          </p:cNvCxnSpPr>
          <p:nvPr/>
        </p:nvCxnSpPr>
        <p:spPr>
          <a:xfrm flipH="1" flipV="1">
            <a:off x="2552285" y="484081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3479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33607416-CAA6-2640-B18C-54BF47D9EC0B}"/>
              </a:ext>
            </a:extLst>
          </p:cNvPr>
          <p:cNvGrpSpPr/>
          <p:nvPr/>
        </p:nvGrpSpPr>
        <p:grpSpPr>
          <a:xfrm>
            <a:off x="481054" y="1114773"/>
            <a:ext cx="5849097" cy="3629632"/>
            <a:chOff x="0" y="3817937"/>
            <a:chExt cx="6858000" cy="4255702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70BAED88-CA52-BE4A-AF5A-F3F4FD97A1A0}"/>
                </a:ext>
              </a:extLst>
            </p:cNvPr>
            <p:cNvGrpSpPr/>
            <p:nvPr/>
          </p:nvGrpSpPr>
          <p:grpSpPr>
            <a:xfrm>
              <a:off x="0" y="3817937"/>
              <a:ext cx="6858000" cy="1859631"/>
              <a:chOff x="-2169528" y="3679914"/>
              <a:chExt cx="9389838" cy="2546170"/>
            </a:xfrm>
          </p:grpSpPr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11455671-BB29-BA40-B7C6-D680B722E8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-2169528" y="3679914"/>
                <a:ext cx="6858000" cy="2546169"/>
              </a:xfrm>
              <a:prstGeom prst="rect">
                <a:avLst/>
              </a:prstGeom>
            </p:spPr>
          </p:pic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DD426628-D7FB-1549-8A2E-257D45B75D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88472" y="3679915"/>
                <a:ext cx="2531838" cy="2546169"/>
              </a:xfrm>
              <a:prstGeom prst="rect">
                <a:avLst/>
              </a:prstGeom>
            </p:spPr>
          </p:pic>
        </p:grp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99BA72A2-2388-1C43-9921-E6A8A1B49DA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5677567"/>
              <a:ext cx="6858000" cy="2396072"/>
            </a:xfrm>
            <a:prstGeom prst="rect">
              <a:avLst/>
            </a:prstGeom>
          </p:spPr>
        </p:pic>
      </p:grp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2D92565E-916C-49E8-9CB9-58A30345B38D}"/>
              </a:ext>
            </a:extLst>
          </p:cNvPr>
          <p:cNvSpPr/>
          <p:nvPr/>
        </p:nvSpPr>
        <p:spPr>
          <a:xfrm>
            <a:off x="3876668" y="5012978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697722FA-D6AF-4A59-8C47-460A5D07AD10}"/>
              </a:ext>
            </a:extLst>
          </p:cNvPr>
          <p:cNvSpPr/>
          <p:nvPr/>
        </p:nvSpPr>
        <p:spPr>
          <a:xfrm>
            <a:off x="2628579" y="5007201"/>
            <a:ext cx="98108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yr109His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0A86D918-42F5-4B19-A2DA-A8ABFF3B628C}"/>
              </a:ext>
            </a:extLst>
          </p:cNvPr>
          <p:cNvGrpSpPr/>
          <p:nvPr/>
        </p:nvGrpSpPr>
        <p:grpSpPr>
          <a:xfrm>
            <a:off x="579840" y="5433343"/>
            <a:ext cx="5698320" cy="1590362"/>
            <a:chOff x="0" y="3686969"/>
            <a:chExt cx="9072467" cy="2532062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E33EB15B-EDF9-4A16-B800-D4A933FA617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3698805"/>
              <a:ext cx="6858000" cy="2508390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78C0FAAE-C9BB-4CCD-9654-490ED7BA320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858000" y="3686969"/>
              <a:ext cx="2214467" cy="2532062"/>
            </a:xfrm>
            <a:prstGeom prst="rect">
              <a:avLst/>
            </a:prstGeom>
          </p:spPr>
        </p:pic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E691B805-6137-4472-A2D0-247AE9B7F343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3047" y="7107085"/>
            <a:ext cx="5745113" cy="1994925"/>
          </a:xfrm>
          <a:prstGeom prst="rect">
            <a:avLst/>
          </a:prstGeom>
        </p:spPr>
      </p:pic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09435C2F-354E-48E7-BC44-0F8144604EC1}"/>
              </a:ext>
            </a:extLst>
          </p:cNvPr>
          <p:cNvSpPr/>
          <p:nvPr/>
        </p:nvSpPr>
        <p:spPr>
          <a:xfrm>
            <a:off x="3571240" y="9369243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D9AB09D5-662D-4105-A35E-F80D338D3A99}"/>
              </a:ext>
            </a:extLst>
          </p:cNvPr>
          <p:cNvSpPr/>
          <p:nvPr/>
        </p:nvSpPr>
        <p:spPr>
          <a:xfrm>
            <a:off x="2223770" y="9369243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Val86Gly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DE46FE9-9CEB-4496-8A80-1FDC33371DB7}"/>
              </a:ext>
            </a:extLst>
          </p:cNvPr>
          <p:cNvSpPr txBox="1"/>
          <p:nvPr/>
        </p:nvSpPr>
        <p:spPr>
          <a:xfrm>
            <a:off x="712266" y="385628"/>
            <a:ext cx="561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s in </a:t>
            </a:r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CF4DC11B-A98D-486E-95C7-E9F9CF710DA6}"/>
              </a:ext>
            </a:extLst>
          </p:cNvPr>
          <p:cNvCxnSpPr>
            <a:cxnSpLocks/>
          </p:cNvCxnSpPr>
          <p:nvPr/>
        </p:nvCxnSpPr>
        <p:spPr>
          <a:xfrm flipH="1" flipV="1">
            <a:off x="4042894" y="8826318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146EB49B-050C-4F6F-A319-517B3CEB2B0D}"/>
              </a:ext>
            </a:extLst>
          </p:cNvPr>
          <p:cNvCxnSpPr>
            <a:cxnSpLocks/>
          </p:cNvCxnSpPr>
          <p:nvPr/>
        </p:nvCxnSpPr>
        <p:spPr>
          <a:xfrm flipV="1">
            <a:off x="2815107" y="8826318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CC660B39-57F0-4A01-AA91-300FF0D70490}"/>
              </a:ext>
            </a:extLst>
          </p:cNvPr>
          <p:cNvCxnSpPr>
            <a:cxnSpLocks/>
          </p:cNvCxnSpPr>
          <p:nvPr/>
        </p:nvCxnSpPr>
        <p:spPr>
          <a:xfrm flipH="1" flipV="1">
            <a:off x="4168232" y="443734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120201BF-09EC-4D92-8072-7F846E40018B}"/>
              </a:ext>
            </a:extLst>
          </p:cNvPr>
          <p:cNvCxnSpPr>
            <a:cxnSpLocks/>
          </p:cNvCxnSpPr>
          <p:nvPr/>
        </p:nvCxnSpPr>
        <p:spPr>
          <a:xfrm flipV="1">
            <a:off x="2940445" y="443734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19303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FB4FDD3-04CF-C14E-8232-F2FFD711DB29}"/>
              </a:ext>
            </a:extLst>
          </p:cNvPr>
          <p:cNvGrpSpPr/>
          <p:nvPr/>
        </p:nvGrpSpPr>
        <p:grpSpPr>
          <a:xfrm>
            <a:off x="396312" y="1216594"/>
            <a:ext cx="6047231" cy="1157781"/>
            <a:chOff x="0" y="4167609"/>
            <a:chExt cx="8204385" cy="1570782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1E3918F-59D9-EE45-831F-86EFC0D95E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167609"/>
              <a:ext cx="6858000" cy="1570782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65A5ADA5-91B0-9749-9252-6C1EAFAF32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858000" y="4167609"/>
              <a:ext cx="1346385" cy="1570782"/>
            </a:xfrm>
            <a:prstGeom prst="rect">
              <a:avLst/>
            </a:prstGeom>
          </p:spPr>
        </p:pic>
      </p:grpSp>
      <p:pic>
        <p:nvPicPr>
          <p:cNvPr id="10" name="図 9">
            <a:extLst>
              <a:ext uri="{FF2B5EF4-FFF2-40B4-BE49-F238E27FC236}">
                <a16:creationId xmlns:a16="http://schemas.microsoft.com/office/drawing/2014/main" id="{16628204-1609-6E4E-B2CA-1156B8B4751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6311" y="2653059"/>
            <a:ext cx="6060353" cy="2117387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4AFEC7B-F3B1-46DB-AAA4-BD91D296A6EC}"/>
              </a:ext>
            </a:extLst>
          </p:cNvPr>
          <p:cNvSpPr/>
          <p:nvPr/>
        </p:nvSpPr>
        <p:spPr>
          <a:xfrm>
            <a:off x="3050475" y="4995154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6C1BA9E-000D-4DC3-A10D-E9AEB18DA1F5}"/>
              </a:ext>
            </a:extLst>
          </p:cNvPr>
          <p:cNvSpPr/>
          <p:nvPr/>
        </p:nvSpPr>
        <p:spPr>
          <a:xfrm>
            <a:off x="5760862" y="4988378"/>
            <a:ext cx="101655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er456Pro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B64CC346-58B8-4CDE-A899-4106C145E769}"/>
              </a:ext>
            </a:extLst>
          </p:cNvPr>
          <p:cNvGrpSpPr/>
          <p:nvPr/>
        </p:nvGrpSpPr>
        <p:grpSpPr>
          <a:xfrm>
            <a:off x="402336" y="5547959"/>
            <a:ext cx="6053328" cy="1417334"/>
            <a:chOff x="-179610" y="3958895"/>
            <a:chExt cx="8491483" cy="1988207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389BC631-4B0D-4314-B116-A4C064D7252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678390" y="3958895"/>
              <a:ext cx="1633483" cy="1988207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77939951-7A3E-4B82-81EF-6C3804CE841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179610" y="3958895"/>
              <a:ext cx="6858000" cy="1988207"/>
            </a:xfrm>
            <a:prstGeom prst="rect">
              <a:avLst/>
            </a:prstGeom>
          </p:spPr>
        </p:pic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42132771-7A57-44B6-AA8A-6B321336C2C8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2336" y="7106851"/>
            <a:ext cx="6053328" cy="2113860"/>
          </a:xfrm>
          <a:prstGeom prst="rect">
            <a:avLst/>
          </a:prstGeom>
        </p:spPr>
      </p:pic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92C511E-5F08-470E-9D5E-B8EC41B55EC0}"/>
              </a:ext>
            </a:extLst>
          </p:cNvPr>
          <p:cNvSpPr/>
          <p:nvPr/>
        </p:nvSpPr>
        <p:spPr>
          <a:xfrm>
            <a:off x="3797743" y="9516608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rg212Arg,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C70BCC5E-75C7-489E-8E41-AB561452D17F}"/>
              </a:ext>
            </a:extLst>
          </p:cNvPr>
          <p:cNvSpPr/>
          <p:nvPr/>
        </p:nvSpPr>
        <p:spPr>
          <a:xfrm>
            <a:off x="1517770" y="9516608"/>
            <a:ext cx="146558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Asp15Ala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887E5C0-F0B9-4846-A6D9-2A98447565FA}"/>
              </a:ext>
            </a:extLst>
          </p:cNvPr>
          <p:cNvSpPr txBox="1"/>
          <p:nvPr/>
        </p:nvSpPr>
        <p:spPr>
          <a:xfrm>
            <a:off x="712266" y="385628"/>
            <a:ext cx="561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s in </a:t>
            </a:r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6665C268-40E5-4799-8EA9-5D7096BB6159}"/>
              </a:ext>
            </a:extLst>
          </p:cNvPr>
          <p:cNvCxnSpPr>
            <a:cxnSpLocks/>
          </p:cNvCxnSpPr>
          <p:nvPr/>
        </p:nvCxnSpPr>
        <p:spPr>
          <a:xfrm flipH="1" flipV="1">
            <a:off x="4042894" y="8923959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25A2CD7E-3898-43B8-B9AC-4CF6C6CDAE9A}"/>
              </a:ext>
            </a:extLst>
          </p:cNvPr>
          <p:cNvCxnSpPr>
            <a:cxnSpLocks/>
          </p:cNvCxnSpPr>
          <p:nvPr/>
        </p:nvCxnSpPr>
        <p:spPr>
          <a:xfrm flipV="1">
            <a:off x="1994840" y="8923959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38E83C27-ABEF-4C1D-B558-8289AD179567}"/>
              </a:ext>
            </a:extLst>
          </p:cNvPr>
          <p:cNvCxnSpPr>
            <a:cxnSpLocks/>
          </p:cNvCxnSpPr>
          <p:nvPr/>
        </p:nvCxnSpPr>
        <p:spPr>
          <a:xfrm flipH="1" flipV="1">
            <a:off x="6091328" y="444909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2D545031-70C9-4760-87D3-AAE78A64CF92}"/>
              </a:ext>
            </a:extLst>
          </p:cNvPr>
          <p:cNvCxnSpPr>
            <a:cxnSpLocks/>
          </p:cNvCxnSpPr>
          <p:nvPr/>
        </p:nvCxnSpPr>
        <p:spPr>
          <a:xfrm flipV="1">
            <a:off x="3774334" y="444909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89501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502184C3-1C09-3A43-B0A4-A40A0AF6F6C3}"/>
              </a:ext>
            </a:extLst>
          </p:cNvPr>
          <p:cNvGrpSpPr/>
          <p:nvPr/>
        </p:nvGrpSpPr>
        <p:grpSpPr>
          <a:xfrm>
            <a:off x="520700" y="2025666"/>
            <a:ext cx="5816599" cy="1504781"/>
            <a:chOff x="-237955" y="3805105"/>
            <a:chExt cx="8874175" cy="2295790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4105E691-D281-F641-A10D-CDCBD09F1E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620045" y="3805105"/>
              <a:ext cx="2016175" cy="2295790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4E89F36A-3B2A-FF48-9A7F-021D45CEAC4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237955" y="3805105"/>
              <a:ext cx="6858000" cy="2295790"/>
            </a:xfrm>
            <a:prstGeom prst="rect">
              <a:avLst/>
            </a:prstGeom>
          </p:spPr>
        </p:pic>
      </p:grpSp>
      <p:pic>
        <p:nvPicPr>
          <p:cNvPr id="10" name="図 9">
            <a:extLst>
              <a:ext uri="{FF2B5EF4-FFF2-40B4-BE49-F238E27FC236}">
                <a16:creationId xmlns:a16="http://schemas.microsoft.com/office/drawing/2014/main" id="{93B0CC16-8958-CC4E-A8A9-51B9DB88F8BC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0700" y="3530510"/>
            <a:ext cx="5816599" cy="2033251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3695BFC-CCEA-4EDC-A274-7B55F80F4DC0}"/>
              </a:ext>
            </a:extLst>
          </p:cNvPr>
          <p:cNvSpPr/>
          <p:nvPr/>
        </p:nvSpPr>
        <p:spPr>
          <a:xfrm>
            <a:off x="3071568" y="5803195"/>
            <a:ext cx="103759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rpsA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Val11Gly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4A1075C0-57CE-4CFF-8E67-063726A68E20}"/>
              </a:ext>
            </a:extLst>
          </p:cNvPr>
          <p:cNvCxnSpPr>
            <a:cxnSpLocks/>
          </p:cNvCxnSpPr>
          <p:nvPr/>
        </p:nvCxnSpPr>
        <p:spPr>
          <a:xfrm flipH="1" flipV="1">
            <a:off x="3178323" y="5293340"/>
            <a:ext cx="250676" cy="4859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00F7BAB-B631-4F38-A10E-C79B0FB19582}"/>
              </a:ext>
            </a:extLst>
          </p:cNvPr>
          <p:cNvSpPr txBox="1"/>
          <p:nvPr/>
        </p:nvSpPr>
        <p:spPr>
          <a:xfrm>
            <a:off x="712266" y="959585"/>
            <a:ext cx="561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s in </a:t>
            </a:r>
            <a:r>
              <a:rPr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rps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2602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19415378-01C7-FC4A-A5E8-AB6A81235F3B}"/>
              </a:ext>
            </a:extLst>
          </p:cNvPr>
          <p:cNvGrpSpPr/>
          <p:nvPr/>
        </p:nvGrpSpPr>
        <p:grpSpPr>
          <a:xfrm>
            <a:off x="327898" y="2083349"/>
            <a:ext cx="6042028" cy="1997564"/>
            <a:chOff x="0" y="3547022"/>
            <a:chExt cx="8505319" cy="2811956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9B2948FF-1083-D842-83B9-A751BA8A4C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858000" y="3547022"/>
              <a:ext cx="1647319" cy="281195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8E96F8D-F389-A146-B1EA-212A22B23FE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3547022"/>
              <a:ext cx="6858000" cy="2811956"/>
            </a:xfrm>
            <a:prstGeom prst="rect">
              <a:avLst/>
            </a:prstGeom>
          </p:spPr>
        </p:pic>
      </p:grpSp>
      <p:pic>
        <p:nvPicPr>
          <p:cNvPr id="12" name="図 11">
            <a:extLst>
              <a:ext uri="{FF2B5EF4-FFF2-40B4-BE49-F238E27FC236}">
                <a16:creationId xmlns:a16="http://schemas.microsoft.com/office/drawing/2014/main" id="{AA62CB49-2338-0446-BB09-F1E19E86592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0396" y="4176330"/>
            <a:ext cx="6038756" cy="212047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212F69-2104-4361-A553-C4E5D0134AEE}"/>
              </a:ext>
            </a:extLst>
          </p:cNvPr>
          <p:cNvSpPr txBox="1"/>
          <p:nvPr/>
        </p:nvSpPr>
        <p:spPr>
          <a:xfrm>
            <a:off x="145569" y="1144251"/>
            <a:ext cx="6566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ptured image of TGS-TB for the mutation in </a:t>
            </a:r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pan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promoter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2199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2</TotalTime>
  <Words>166</Words>
  <Application>Microsoft Office PowerPoint</Application>
  <PresentationFormat>A4 210 x 297 mm</PresentationFormat>
  <Paragraphs>24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黒田誠</dc:creator>
  <cp:lastModifiedBy>tomotada</cp:lastModifiedBy>
  <cp:revision>85</cp:revision>
  <cp:lastPrinted>2018-12-23T09:52:01Z</cp:lastPrinted>
  <dcterms:created xsi:type="dcterms:W3CDTF">2018-12-19T23:25:25Z</dcterms:created>
  <dcterms:modified xsi:type="dcterms:W3CDTF">2018-12-24T09:54:46Z</dcterms:modified>
</cp:coreProperties>
</file>